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53" r:id="rId2"/>
    <p:sldId id="2285" r:id="rId3"/>
    <p:sldId id="2286" r:id="rId4"/>
    <p:sldId id="2287" r:id="rId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04" userDrawn="1">
          <p15:clr>
            <a:srgbClr val="A4A3A4"/>
          </p15:clr>
        </p15:guide>
        <p15:guide id="2" pos="41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583" y="48"/>
      </p:cViewPr>
      <p:guideLst>
        <p:guide orient="horz" pos="3504"/>
        <p:guide pos="41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4525F-EBF1-BCA5-6FD6-27EE471CCF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997CD5-530E-28D8-14A4-FC875EA42F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463887-04BD-DB83-EC51-68C020584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E99BA-63AD-1941-B219-8D353FA98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2E87A-9B32-ACE7-BC38-534EC89B8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434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4A06A4-C87B-CBB9-CA8B-70ECA06EA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8AD929-B7E5-5F55-D18B-A759439B60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91CAB6-2B01-16F6-821E-C30165D98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819390-2441-0AB8-2965-C97837615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919760-FE16-CFC6-DD8D-519563495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630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D00A34-D08E-E004-D2E3-7CAF2E918F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A297CE-8989-F6B7-77BE-9B97A22411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F21119-0338-FE18-2A08-DA44B4CF9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6DFE24-5B08-8350-3C51-3D0B5BC4B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CFCA76-F2C0-3964-7A57-3178515BF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74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7145B-2BAB-CA52-404B-F4F56F3FD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2DF30D-BA52-83F4-40F6-DA6614116C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343F78-FDFE-2630-D63B-A854AA501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8819A-DA90-98B6-FE2B-1AB2B3245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C64123-851B-00EE-5731-D39520117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757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673E73-9BF4-3907-0961-EF013099D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EAEF16-B919-5CCA-8411-BFCF67FEAD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37E43A-4B83-4DD3-8E30-49A8466E7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E2108-D325-1A70-A1CF-865B77546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339DB-EF4E-E08B-3CB6-14F7266FA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696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8585A-DBEC-882B-0812-2653A4C6DE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95A792-CF10-3C8C-000F-0133A51708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3637FF-082B-284A-621C-C7E8F7AE88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62A671-2DBA-17CB-0835-952A4E35A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199FE6-1189-CB07-1C84-4AEF42A9B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EE3801-F22F-6D3A-BA07-FAB7DE856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856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95AF6-C49C-1D76-51CE-BFAD5DDA23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B8BC66-9F15-8E25-93DA-4D834524F5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D913F3-54C2-2CAC-D8F2-A8BD2A2D6D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6127D7-C2AF-6ADC-B201-B361997BD0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7C1D73-CE94-F300-AE6D-FC9C209055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A783DA-04F6-B702-990C-1133545DB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1CFA1B-2CAD-E47E-084D-66137E38D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478AA3-B4AB-32A5-5ACA-317DA89D4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259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72DE83-90A8-BE03-105C-C72E6F531F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34C7C-8170-68B2-9846-11E98D10C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446880-4C4B-774F-204E-B92740EF6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96B64A-F4AE-1644-6405-F5EB6C04E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509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2300A1-BA64-7418-174D-DBBC1404A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7E55E8-9B64-5C53-CBF8-EB4039D32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BB9F69-88E6-5A15-AF50-337DACD7F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58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89195-1991-D624-3C3E-BE4C8963A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79617E-F6F2-7564-FD02-C893E46A2B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F853E-564B-0F4E-7835-34F2E26460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B78365-9D60-4126-64E2-83BF5491D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8812B0-449A-61A4-CD6B-40DBC3957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9F1625-7960-DF35-4659-3245C61E8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424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0D8B9-52CA-B5AC-3BF1-4B9F8EA026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2999E9-A5BE-F4AD-2682-B4D10BE8DE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D242CF-65D5-0741-21D4-81DA4F4917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01D5F1-60E2-D438-521F-910AE2C16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67CE23-3332-05BD-EC1F-59ACE23A6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1AD053-22B2-B1C6-DDC5-F474A3121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31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230609-C3F5-9FDE-5434-C9F0DFA4B7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00ACC9-3493-3B53-6362-BC7A2229DA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D2A86C-9829-C80C-91DE-1D5DDEF87F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53F3F-CDBD-4F47-9610-4863197F06E1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9DE46-61A8-92D8-EEC7-2347D436BA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5E91D2-B6F1-F87F-BC6F-323718BA88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DBE64-C229-49E4-9F90-1C5BD5363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465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8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10" Type="http://schemas.openxmlformats.org/officeDocument/2006/relationships/image" Target="../media/image10.png"/><Relationship Id="rId4" Type="http://schemas.openxmlformats.org/officeDocument/2006/relationships/image" Target="../media/image6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microsoft.com/office/2007/relationships/hdphoto" Target="../media/hdphoto4.wdp"/><Relationship Id="rId7" Type="http://schemas.openxmlformats.org/officeDocument/2006/relationships/image" Target="../media/image5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microsoft.com/office/2007/relationships/hdphoto" Target="../media/hdphoto5.wdp"/><Relationship Id="rId10" Type="http://schemas.microsoft.com/office/2007/relationships/hdphoto" Target="../media/hdphoto2.wdp"/><Relationship Id="rId4" Type="http://schemas.openxmlformats.org/officeDocument/2006/relationships/image" Target="../media/image12.pn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C4392B9-D754-6DC2-3187-E23BB929F7F2}"/>
              </a:ext>
            </a:extLst>
          </p:cNvPr>
          <p:cNvSpPr txBox="1"/>
          <p:nvPr/>
        </p:nvSpPr>
        <p:spPr>
          <a:xfrm>
            <a:off x="156764" y="4239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874F231-CCA2-8253-D383-A1F0E27CB1E8}"/>
              </a:ext>
            </a:extLst>
          </p:cNvPr>
          <p:cNvGrpSpPr/>
          <p:nvPr/>
        </p:nvGrpSpPr>
        <p:grpSpPr>
          <a:xfrm>
            <a:off x="1126001" y="768824"/>
            <a:ext cx="10372757" cy="5392606"/>
            <a:chOff x="1126001" y="768824"/>
            <a:chExt cx="10372757" cy="539260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F40CB48-F9D9-C415-E607-89DC7EE9B77F}"/>
                </a:ext>
              </a:extLst>
            </p:cNvPr>
            <p:cNvGrpSpPr/>
            <p:nvPr/>
          </p:nvGrpSpPr>
          <p:grpSpPr>
            <a:xfrm>
              <a:off x="1132764" y="768824"/>
              <a:ext cx="10365994" cy="5392606"/>
              <a:chOff x="941965" y="230789"/>
              <a:chExt cx="9705289" cy="4924317"/>
            </a:xfrm>
          </p:grpSpPr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BEA1CD6B-160C-7EE7-873A-5B3D93D7172A}"/>
                  </a:ext>
                </a:extLst>
              </p:cNvPr>
              <p:cNvGrpSpPr/>
              <p:nvPr/>
            </p:nvGrpSpPr>
            <p:grpSpPr>
              <a:xfrm>
                <a:off x="941965" y="230789"/>
                <a:ext cx="3939317" cy="4924317"/>
                <a:chOff x="2123340" y="0"/>
                <a:chExt cx="3939317" cy="4924317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9874E766-00A2-4FCE-F401-B2DC04E83793}"/>
                    </a:ext>
                  </a:extLst>
                </p:cNvPr>
                <p:cNvGrpSpPr/>
                <p:nvPr/>
              </p:nvGrpSpPr>
              <p:grpSpPr>
                <a:xfrm>
                  <a:off x="2123340" y="0"/>
                  <a:ext cx="3873760" cy="4801314"/>
                  <a:chOff x="1204392" y="551543"/>
                  <a:chExt cx="3873760" cy="4980386"/>
                </a:xfrm>
              </p:grpSpPr>
              <p:graphicFrame>
                <p:nvGraphicFramePr>
                  <p:cNvPr id="4" name="Object 3">
                    <a:extLst>
                      <a:ext uri="{FF2B5EF4-FFF2-40B4-BE49-F238E27FC236}">
                        <a16:creationId xmlns:a16="http://schemas.microsoft.com/office/drawing/2014/main" id="{1BEB5C4C-4FC9-0CD4-63D2-C2737F8C08D0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1534852" y="706274"/>
                  <a:ext cx="3543300" cy="178752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7" r:id="rId2" imgW="6281202" imgH="3192500" progId="Prism7.Document">
                          <p:embed/>
                        </p:oleObj>
                      </mc:Choice>
                      <mc:Fallback>
                        <p:oleObj name="Prism 7" r:id="rId2" imgW="6281202" imgH="3192500" progId="Prism7.Document">
                          <p:embed/>
                          <p:pic>
                            <p:nvPicPr>
                              <p:cNvPr id="4" name="Object 3">
                                <a:extLst>
                                  <a:ext uri="{FF2B5EF4-FFF2-40B4-BE49-F238E27FC236}">
                                    <a16:creationId xmlns:a16="http://schemas.microsoft.com/office/drawing/2014/main" id="{1BEB5C4C-4FC9-0CD4-63D2-C2737F8C08D0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534852" y="706274"/>
                                <a:ext cx="3543300" cy="178752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4D3CAFA1-26BF-38EC-B837-66530976312E}"/>
                      </a:ext>
                    </a:extLst>
                  </p:cNvPr>
                  <p:cNvSpPr txBox="1"/>
                  <p:nvPr/>
                </p:nvSpPr>
                <p:spPr>
                  <a:xfrm>
                    <a:off x="1204392" y="551543"/>
                    <a:ext cx="324128" cy="498038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b="1" dirty="0"/>
                      <a:t>A</a:t>
                    </a:r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r>
                      <a:rPr lang="en-US" b="1" dirty="0"/>
                      <a:t>B</a:t>
                    </a:r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r>
                      <a:rPr lang="en-US" b="1" dirty="0"/>
                      <a:t>C</a:t>
                    </a:r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  <a:p>
                    <a:endParaRPr lang="en-US" b="1" dirty="0"/>
                  </a:p>
                </p:txBody>
              </p:sp>
            </p:grpSp>
            <p:pic>
              <p:nvPicPr>
                <p:cNvPr id="24" name="Picture 23">
                  <a:extLst>
                    <a:ext uri="{FF2B5EF4-FFF2-40B4-BE49-F238E27FC236}">
                      <a16:creationId xmlns:a16="http://schemas.microsoft.com/office/drawing/2014/main" id="{4E933401-FBCF-D7EA-6002-EF761245C1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388323" y="3033688"/>
                  <a:ext cx="3674334" cy="1890629"/>
                </a:xfrm>
                <a:prstGeom prst="rect">
                  <a:avLst/>
                </a:prstGeom>
              </p:spPr>
            </p:pic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E1071447-4EE0-5E5D-51A6-95EB2488A8C8}"/>
                    </a:ext>
                  </a:extLst>
                </p:cNvPr>
                <p:cNvSpPr txBox="1"/>
                <p:nvPr/>
              </p:nvSpPr>
              <p:spPr>
                <a:xfrm>
                  <a:off x="3327060" y="3448123"/>
                  <a:ext cx="543739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/>
                    <a:t>F11</a:t>
                  </a:r>
                </a:p>
                <a:p>
                  <a:r>
                    <a:rPr lang="en-US" sz="1400" dirty="0"/>
                    <a:t>RA-V</a:t>
                  </a:r>
                </a:p>
              </p:txBody>
            </p: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2638C662-2B0D-68AF-ED59-2C860347DA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03969" y="3617497"/>
                  <a:ext cx="249947" cy="0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75CFBBFB-0DDD-3E7B-4422-C65CD040D1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16348" y="3814936"/>
                  <a:ext cx="237568" cy="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0" name="图片 8">
                <a:extLst>
                  <a:ext uri="{FF2B5EF4-FFF2-40B4-BE49-F238E27FC236}">
                    <a16:creationId xmlns:a16="http://schemas.microsoft.com/office/drawing/2014/main" id="{A2A25F5E-66AD-C373-0D8D-ADA25FD89D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146265" y="598501"/>
                <a:ext cx="5500989" cy="3141911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7C1351A-458F-928D-8097-FC3B246E8910}"/>
                  </a:ext>
                </a:extLst>
              </p:cNvPr>
              <p:cNvSpPr txBox="1"/>
              <p:nvPr/>
            </p:nvSpPr>
            <p:spPr>
              <a:xfrm>
                <a:off x="3093785" y="3428655"/>
                <a:ext cx="1351954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dirty="0"/>
                  <a:t>M+1H  </a:t>
                </a:r>
              </a:p>
              <a:p>
                <a:r>
                  <a:rPr lang="en-US" sz="1400" dirty="0"/>
                  <a:t>m/z=757.3549 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FD3FBA9D-3E0B-CBEC-386E-08A207659478}"/>
                  </a:ext>
                </a:extLst>
              </p:cNvPr>
              <p:cNvSpPr txBox="1"/>
              <p:nvPr/>
            </p:nvSpPr>
            <p:spPr>
              <a:xfrm>
                <a:off x="5029803" y="230789"/>
                <a:ext cx="3273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D</a:t>
                </a:r>
              </a:p>
            </p:txBody>
          </p:sp>
        </p:grp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5EB64D3-D1E4-7EFD-E513-9A457B9B7D5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26001" y="2941268"/>
              <a:ext cx="4528264" cy="61521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054A6E9E-B048-1F59-B00A-7CDC31C001F3}"/>
              </a:ext>
            </a:extLst>
          </p:cNvPr>
          <p:cNvSpPr txBox="1"/>
          <p:nvPr/>
        </p:nvSpPr>
        <p:spPr>
          <a:xfrm>
            <a:off x="5619189" y="4776435"/>
            <a:ext cx="60960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Figure S1. Identification of chemical responsible for down-regulating AR and AR-V. (A) Effect of YIV-818-A and fractions (250 ug/ml, equivalent concentration) eluted from C18 column on AR driven luciferase activity of 22RV1 AR-luciferase reporter cells. (B) Western blotting analysis for the effect of  YIV-818-A and fractions (250ug/ml, equivalent concentration) eluted from C18 column on AR and AR-V expression of 22RV1 cells. (C) High resolution LC-MS analysis for chemical of F11 and RA-V (standard). (D) Mass spectrum of high resolution MS for detection M+H, M+Na of RA-V.</a:t>
            </a:r>
          </a:p>
        </p:txBody>
      </p:sp>
    </p:spTree>
    <p:extLst>
      <p:ext uri="{BB962C8B-B14F-4D97-AF65-F5344CB8AC3E}">
        <p14:creationId xmlns:p14="http://schemas.microsoft.com/office/powerpoint/2010/main" val="682820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3CAC6EB-1BC5-5C14-142C-4362906CE655}"/>
              </a:ext>
            </a:extLst>
          </p:cNvPr>
          <p:cNvSpPr txBox="1"/>
          <p:nvPr/>
        </p:nvSpPr>
        <p:spPr>
          <a:xfrm rot="16200000">
            <a:off x="4483505" y="900896"/>
            <a:ext cx="1124026" cy="2203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/>
              <a:t>Contro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Y1830, 83 u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Y1830, 250 u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, 25 n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, 75 n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II, 8.3 n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II, 25 ng/ml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9F433D3-DAEA-A02E-DCC6-C3706CBE3144}"/>
              </a:ext>
            </a:extLst>
          </p:cNvPr>
          <p:cNvCxnSpPr>
            <a:cxnSpLocks/>
          </p:cNvCxnSpPr>
          <p:nvPr/>
        </p:nvCxnSpPr>
        <p:spPr>
          <a:xfrm flipV="1">
            <a:off x="6175427" y="1451612"/>
            <a:ext cx="1998266" cy="965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E1E1D02-002F-3B5C-FE58-C31FAF368152}"/>
              </a:ext>
            </a:extLst>
          </p:cNvPr>
          <p:cNvSpPr txBox="1"/>
          <p:nvPr/>
        </p:nvSpPr>
        <p:spPr>
          <a:xfrm>
            <a:off x="6804816" y="1006063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DH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AD5A83-4756-2A85-768F-F2642E0D18EB}"/>
              </a:ext>
            </a:extLst>
          </p:cNvPr>
          <p:cNvSpPr txBox="1"/>
          <p:nvPr/>
        </p:nvSpPr>
        <p:spPr>
          <a:xfrm>
            <a:off x="4531430" y="1006063"/>
            <a:ext cx="1268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NCAP cells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2ED917C-1858-0462-6088-9A978A0476BB}"/>
              </a:ext>
            </a:extLst>
          </p:cNvPr>
          <p:cNvGrpSpPr/>
          <p:nvPr/>
        </p:nvGrpSpPr>
        <p:grpSpPr>
          <a:xfrm>
            <a:off x="3375412" y="2548007"/>
            <a:ext cx="4848628" cy="1527494"/>
            <a:chOff x="1935572" y="2909751"/>
            <a:chExt cx="4848628" cy="152749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60DC560-F1D3-52C8-0BE4-A3B996E08E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5000"/>
                      </a14:imgEffect>
                    </a14:imgLayer>
                  </a14:imgProps>
                </a:ext>
              </a:extLst>
            </a:blip>
            <a:srcRect l="2412" t="666" r="41505" b="40926"/>
            <a:stretch/>
          </p:blipFill>
          <p:spPr>
            <a:xfrm>
              <a:off x="2588379" y="2909753"/>
              <a:ext cx="2079155" cy="42559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0604A47-80A1-BE2A-1DFF-48D3DAFEFD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5000" contrast="5000"/>
                      </a14:imgEffect>
                    </a14:imgLayer>
                  </a14:imgProps>
                </a:ext>
              </a:extLst>
            </a:blip>
            <a:srcRect l="9330" t="-665" r="38451" b="39026"/>
            <a:stretch/>
          </p:blipFill>
          <p:spPr>
            <a:xfrm>
              <a:off x="4721848" y="2909751"/>
              <a:ext cx="2062352" cy="425595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E25165D-84FB-8042-B15B-4A5106D33C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677" t="6680" r="41103" b="22201"/>
            <a:stretch/>
          </p:blipFill>
          <p:spPr>
            <a:xfrm>
              <a:off x="2588380" y="3898710"/>
              <a:ext cx="2079154" cy="53853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16FFB9D-6168-4F0B-55B6-585653B415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5000"/>
                      </a14:imgEffect>
                    </a14:imgLayer>
                  </a14:imgProps>
                </a:ext>
              </a:extLst>
            </a:blip>
            <a:srcRect t="-1" r="45842" b="5591"/>
            <a:stretch/>
          </p:blipFill>
          <p:spPr>
            <a:xfrm>
              <a:off x="4713445" y="3907532"/>
              <a:ext cx="2070755" cy="52089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FB85227-C70A-42DF-22F2-EA4C803B67E4}"/>
                </a:ext>
              </a:extLst>
            </p:cNvPr>
            <p:cNvSpPr txBox="1"/>
            <p:nvPr/>
          </p:nvSpPr>
          <p:spPr>
            <a:xfrm>
              <a:off x="1935572" y="2972488"/>
              <a:ext cx="652807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AR</a:t>
              </a:r>
            </a:p>
            <a:p>
              <a:pPr algn="r"/>
              <a:endParaRPr lang="en-US" sz="1200" b="1" dirty="0"/>
            </a:p>
            <a:p>
              <a:pPr algn="r"/>
              <a:endParaRPr lang="en-US" sz="1200" b="1" dirty="0"/>
            </a:p>
            <a:p>
              <a:pPr algn="r"/>
              <a:r>
                <a:rPr lang="en-US" sz="1200" b="1" dirty="0"/>
                <a:t>cycD1</a:t>
              </a:r>
            </a:p>
            <a:p>
              <a:pPr algn="r"/>
              <a:endParaRPr lang="en-US" sz="1200" b="1" dirty="0"/>
            </a:p>
            <a:p>
              <a:pPr algn="r"/>
              <a:endParaRPr lang="en-US" sz="1200" b="1" dirty="0"/>
            </a:p>
            <a:p>
              <a:pPr algn="r"/>
              <a:r>
                <a:rPr lang="en-US" sz="1200" b="1" dirty="0"/>
                <a:t>GAPDH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572C639-D12E-7640-A422-3672A3484C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r="41131"/>
            <a:stretch/>
          </p:blipFill>
          <p:spPr>
            <a:xfrm>
              <a:off x="2588379" y="3415110"/>
              <a:ext cx="2079156" cy="431127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EE8FCF5F-70A3-AF2D-2A1B-B31B017BED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918" t="537" r="40253"/>
            <a:stretch/>
          </p:blipFill>
          <p:spPr>
            <a:xfrm>
              <a:off x="4721848" y="3425418"/>
              <a:ext cx="2062352" cy="418563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06BD31E5-B1B1-4F81-B7F6-77CB5BA2C7A3}"/>
              </a:ext>
            </a:extLst>
          </p:cNvPr>
          <p:cNvSpPr txBox="1"/>
          <p:nvPr/>
        </p:nvSpPr>
        <p:spPr>
          <a:xfrm rot="16200000">
            <a:off x="6592418" y="898581"/>
            <a:ext cx="1124026" cy="2203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/>
              <a:t>Contro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Y1830, 83 u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Y1830, 250 u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, 25 n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, 75 n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II, 8.3 ng/ml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RA-VII, 25 ng/m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D4A057-59DA-46A1-3236-A4368A2621B4}"/>
              </a:ext>
            </a:extLst>
          </p:cNvPr>
          <p:cNvSpPr txBox="1"/>
          <p:nvPr/>
        </p:nvSpPr>
        <p:spPr>
          <a:xfrm>
            <a:off x="156764" y="4239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5C1DAA-54AB-9BF0-9362-7AFB0F70152B}"/>
              </a:ext>
            </a:extLst>
          </p:cNvPr>
          <p:cNvSpPr txBox="1"/>
          <p:nvPr/>
        </p:nvSpPr>
        <p:spPr>
          <a:xfrm>
            <a:off x="2370256" y="5233556"/>
            <a:ext cx="736466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Figure 2S</a:t>
            </a:r>
            <a:r>
              <a:rPr lang="en-US" sz="1200" dirty="0"/>
              <a:t>. Western blotting for protein expression of  AR, and CycD1 of LNCAP cells following treatment of YIV-818-A, RA-V and RA-VII without or with DHT (25 nM) for 24h hours. </a:t>
            </a:r>
          </a:p>
        </p:txBody>
      </p:sp>
    </p:spTree>
    <p:extLst>
      <p:ext uri="{BB962C8B-B14F-4D97-AF65-F5344CB8AC3E}">
        <p14:creationId xmlns:p14="http://schemas.microsoft.com/office/powerpoint/2010/main" val="34108064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19FF6081-8CF2-A387-E032-B345964C8CFF}"/>
              </a:ext>
            </a:extLst>
          </p:cNvPr>
          <p:cNvGrpSpPr/>
          <p:nvPr/>
        </p:nvGrpSpPr>
        <p:grpSpPr>
          <a:xfrm>
            <a:off x="3903014" y="1161226"/>
            <a:ext cx="7864862" cy="3724041"/>
            <a:chOff x="802211" y="989382"/>
            <a:chExt cx="9553089" cy="459474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871C7ED-4205-433F-DF4E-864B967AB5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371230" y="1273877"/>
              <a:ext cx="8535140" cy="431024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C229FB4-6841-0ADE-3922-38E0E68B847B}"/>
                </a:ext>
              </a:extLst>
            </p:cNvPr>
            <p:cNvSpPr txBox="1"/>
            <p:nvPr/>
          </p:nvSpPr>
          <p:spPr>
            <a:xfrm>
              <a:off x="802211" y="1536174"/>
              <a:ext cx="569019" cy="3987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solidFill>
                    <a:srgbClr val="0070C0"/>
                  </a:solidFill>
                </a:rPr>
                <a:t>DNA</a:t>
              </a:r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r>
                <a:rPr lang="en-US" sz="1200" dirty="0">
                  <a:solidFill>
                    <a:srgbClr val="C00000"/>
                  </a:solidFill>
                </a:rPr>
                <a:t>AR</a:t>
              </a:r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r>
                <a:rPr lang="en-US" sz="1200" dirty="0">
                  <a:solidFill>
                    <a:srgbClr val="00B050"/>
                  </a:solidFill>
                </a:rPr>
                <a:t>GR</a:t>
              </a:r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endParaRPr lang="en-US" sz="1200" dirty="0"/>
            </a:p>
            <a:p>
              <a:pPr algn="r"/>
              <a:r>
                <a:rPr lang="en-US" sz="1200" dirty="0">
                  <a:solidFill>
                    <a:srgbClr val="0070C0"/>
                  </a:solidFill>
                </a:rPr>
                <a:t>DNA</a:t>
              </a:r>
            </a:p>
            <a:p>
              <a:pPr algn="r"/>
              <a:r>
                <a:rPr lang="en-US" sz="1200" dirty="0"/>
                <a:t>/</a:t>
              </a:r>
              <a:r>
                <a:rPr lang="en-US" sz="1200" dirty="0">
                  <a:solidFill>
                    <a:srgbClr val="C00000"/>
                  </a:solidFill>
                </a:rPr>
                <a:t>AR</a:t>
              </a:r>
            </a:p>
            <a:p>
              <a:pPr algn="r"/>
              <a:r>
                <a:rPr lang="en-US" sz="1200" dirty="0"/>
                <a:t>/</a:t>
              </a:r>
              <a:r>
                <a:rPr lang="en-US" sz="1200" dirty="0">
                  <a:solidFill>
                    <a:srgbClr val="00B050"/>
                  </a:solidFill>
                </a:rPr>
                <a:t>GR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6E82D39-FF5E-AEE8-93B0-1B7485614D0A}"/>
                </a:ext>
              </a:extLst>
            </p:cNvPr>
            <p:cNvSpPr txBox="1"/>
            <p:nvPr/>
          </p:nvSpPr>
          <p:spPr>
            <a:xfrm>
              <a:off x="1591038" y="989382"/>
              <a:ext cx="8764262" cy="2848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</a:t>
              </a:r>
              <a:r>
                <a:rPr lang="en-US" sz="900" dirty="0" err="1"/>
                <a:t>Control</a:t>
              </a:r>
              <a:r>
                <a:rPr lang="en-US" sz="900" dirty="0"/>
                <a:t>                Y1830 83 ug/ml      Y1830 250 ug/ml     RA-V 25 ng/ml       RA-V  75 ng/ml       RA-VII  8.3 ng/ml    RA-VII  25  ng/ml 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0A2DFD12-3BFE-A129-0110-27AD9E6A748F}"/>
              </a:ext>
            </a:extLst>
          </p:cNvPr>
          <p:cNvSpPr txBox="1"/>
          <p:nvPr/>
        </p:nvSpPr>
        <p:spPr>
          <a:xfrm>
            <a:off x="156764" y="4239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D3AF5DF-246F-5BFD-5177-B55CFF64CF25}"/>
              </a:ext>
            </a:extLst>
          </p:cNvPr>
          <p:cNvSpPr txBox="1"/>
          <p:nvPr/>
        </p:nvSpPr>
        <p:spPr>
          <a:xfrm>
            <a:off x="1103398" y="5469467"/>
            <a:ext cx="98024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</a:t>
            </a:r>
            <a:r>
              <a:rPr lang="en-US" sz="1200" dirty="0"/>
              <a:t>. Effect of YIV-818-A, RA-V and RA-V on GR, AR protein expression (</a:t>
            </a:r>
            <a:r>
              <a:rPr lang="en-US" sz="1200" b="1" dirty="0"/>
              <a:t>A</a:t>
            </a:r>
            <a:r>
              <a:rPr lang="en-US" sz="1200" dirty="0"/>
              <a:t>) and GR nuclear localization (</a:t>
            </a:r>
            <a:r>
              <a:rPr lang="en-US" sz="1200" b="1" dirty="0"/>
              <a:t>B</a:t>
            </a:r>
            <a:r>
              <a:rPr lang="en-US" sz="1200" dirty="0"/>
              <a:t>) of 22RV1 cells in present of DEX. Immunofluorescence micrographs for showing cellular localization of AR and GR in 22RV1 cells. Nuclear DNA was stained with DAPI. AR was stained anti-AR-Alex-568 antibody. GR was stained with anti-GR-Alexa-488 antibody. Details of experimental procedures are given in Materials and Methods.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E18F07D1-09AA-9E18-E3C2-7F55DDB008D9}"/>
              </a:ext>
            </a:extLst>
          </p:cNvPr>
          <p:cNvCxnSpPr>
            <a:cxnSpLocks/>
          </p:cNvCxnSpPr>
          <p:nvPr/>
        </p:nvCxnSpPr>
        <p:spPr>
          <a:xfrm>
            <a:off x="5302552" y="1155178"/>
            <a:ext cx="609572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0E0DE646-9B92-BF09-DC4B-EBE8247756CE}"/>
              </a:ext>
            </a:extLst>
          </p:cNvPr>
          <p:cNvSpPr txBox="1"/>
          <p:nvPr/>
        </p:nvSpPr>
        <p:spPr>
          <a:xfrm>
            <a:off x="7822564" y="766363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DEX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E0222DC-9A9D-372D-8B86-4D67B5EFB452}"/>
              </a:ext>
            </a:extLst>
          </p:cNvPr>
          <p:cNvGrpSpPr/>
          <p:nvPr/>
        </p:nvGrpSpPr>
        <p:grpSpPr>
          <a:xfrm>
            <a:off x="1524631" y="1498947"/>
            <a:ext cx="2203680" cy="3164078"/>
            <a:chOff x="2327755" y="1700355"/>
            <a:chExt cx="2203680" cy="3164078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7A296B2-C733-1FD0-816D-35D1D0A6E4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015" t="7684" r="46899"/>
            <a:stretch/>
          </p:blipFill>
          <p:spPr>
            <a:xfrm>
              <a:off x="2448075" y="2751084"/>
              <a:ext cx="2036840" cy="52207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490FC3C-BBFA-AD87-AE92-1024383185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764" t="4263" r="29618"/>
            <a:stretch/>
          </p:blipFill>
          <p:spPr>
            <a:xfrm>
              <a:off x="2448076" y="4475476"/>
              <a:ext cx="2036838" cy="388957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4369E4C1-B2CA-291F-291A-60239E39D3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5000"/>
                      </a14:imgEffect>
                    </a14:imgLayer>
                  </a14:imgProps>
                </a:ext>
              </a:extLst>
            </a:blip>
            <a:srcRect l="2412" t="-94" r="42162"/>
            <a:stretch/>
          </p:blipFill>
          <p:spPr>
            <a:xfrm>
              <a:off x="2448076" y="3288158"/>
              <a:ext cx="2036839" cy="729343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368DEBE8-1C0C-FC0A-90EC-205E010D52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5000" contrast="15000"/>
                      </a14:imgEffect>
                    </a14:imgLayer>
                  </a14:imgProps>
                </a:ext>
              </a:extLst>
            </a:blip>
            <a:srcRect l="8809" t="45072" r="36778"/>
            <a:stretch/>
          </p:blipFill>
          <p:spPr>
            <a:xfrm>
              <a:off x="2448075" y="4047509"/>
              <a:ext cx="2036839" cy="397959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6FC7B6C-48E0-88D4-2BBE-6BAEB6C93A92}"/>
                </a:ext>
              </a:extLst>
            </p:cNvPr>
            <p:cNvSpPr txBox="1"/>
            <p:nvPr/>
          </p:nvSpPr>
          <p:spPr>
            <a:xfrm rot="16200000">
              <a:off x="2867582" y="1160528"/>
              <a:ext cx="1124026" cy="22036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000" b="1" dirty="0"/>
                <a:t>Control</a:t>
              </a:r>
            </a:p>
            <a:p>
              <a:pPr>
                <a:lnSpc>
                  <a:spcPct val="200000"/>
                </a:lnSpc>
              </a:pPr>
              <a:r>
                <a:rPr lang="en-US" sz="1000" b="1" dirty="0"/>
                <a:t>Y1830, 83 ug/ml</a:t>
              </a:r>
            </a:p>
            <a:p>
              <a:pPr>
                <a:lnSpc>
                  <a:spcPct val="200000"/>
                </a:lnSpc>
              </a:pPr>
              <a:r>
                <a:rPr lang="en-US" sz="1000" b="1" dirty="0"/>
                <a:t>Y1830, 250 ug/ml</a:t>
              </a:r>
            </a:p>
            <a:p>
              <a:pPr>
                <a:lnSpc>
                  <a:spcPct val="200000"/>
                </a:lnSpc>
              </a:pPr>
              <a:r>
                <a:rPr lang="en-US" sz="1000" b="1" dirty="0"/>
                <a:t>RA-V, 25 ng/ml</a:t>
              </a:r>
            </a:p>
            <a:p>
              <a:pPr>
                <a:lnSpc>
                  <a:spcPct val="200000"/>
                </a:lnSpc>
              </a:pPr>
              <a:r>
                <a:rPr lang="en-US" sz="1000" b="1" dirty="0"/>
                <a:t>RA-V, 75 ng/ml</a:t>
              </a:r>
            </a:p>
            <a:p>
              <a:pPr>
                <a:lnSpc>
                  <a:spcPct val="200000"/>
                </a:lnSpc>
              </a:pPr>
              <a:r>
                <a:rPr lang="en-US" sz="1000" b="1" dirty="0"/>
                <a:t>RA-VII, 8.3 ng/ml</a:t>
              </a:r>
            </a:p>
            <a:p>
              <a:pPr>
                <a:lnSpc>
                  <a:spcPct val="200000"/>
                </a:lnSpc>
              </a:pPr>
              <a:r>
                <a:rPr lang="en-US" sz="1000" b="1" dirty="0"/>
                <a:t>RA-VII, 25 ng/ml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732A0466-3136-3ABC-2269-B042B79C900B}"/>
              </a:ext>
            </a:extLst>
          </p:cNvPr>
          <p:cNvSpPr txBox="1"/>
          <p:nvPr/>
        </p:nvSpPr>
        <p:spPr>
          <a:xfrm>
            <a:off x="1362567" y="122444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B0C560A-E9BA-A640-50A2-CBD17DFFB57A}"/>
              </a:ext>
            </a:extLst>
          </p:cNvPr>
          <p:cNvSpPr txBox="1"/>
          <p:nvPr/>
        </p:nvSpPr>
        <p:spPr>
          <a:xfrm>
            <a:off x="1032219" y="2641705"/>
            <a:ext cx="612732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b="1" dirty="0"/>
              <a:t>GR</a:t>
            </a:r>
          </a:p>
          <a:p>
            <a:pPr algn="r"/>
            <a:endParaRPr lang="en-US" sz="1100" b="1" dirty="0"/>
          </a:p>
          <a:p>
            <a:pPr algn="r"/>
            <a:endParaRPr lang="en-US" sz="1100" b="1" dirty="0"/>
          </a:p>
          <a:p>
            <a:pPr algn="r"/>
            <a:r>
              <a:rPr lang="en-US" sz="1100" b="1" dirty="0"/>
              <a:t>AR</a:t>
            </a:r>
          </a:p>
          <a:p>
            <a:pPr algn="r"/>
            <a:endParaRPr lang="en-US" sz="1100" b="1" dirty="0"/>
          </a:p>
          <a:p>
            <a:pPr algn="r"/>
            <a:r>
              <a:rPr lang="en-US" sz="1100" b="1" dirty="0"/>
              <a:t>AR-V</a:t>
            </a:r>
          </a:p>
          <a:p>
            <a:pPr algn="r"/>
            <a:endParaRPr lang="en-US" sz="1100" b="1" dirty="0"/>
          </a:p>
          <a:p>
            <a:pPr algn="r"/>
            <a:endParaRPr lang="en-US" sz="500" b="1" dirty="0"/>
          </a:p>
          <a:p>
            <a:pPr algn="r"/>
            <a:r>
              <a:rPr lang="en-US" sz="1100" b="1" dirty="0"/>
              <a:t>cycD1</a:t>
            </a:r>
          </a:p>
          <a:p>
            <a:pPr algn="r"/>
            <a:endParaRPr lang="en-US" sz="1100" b="1" dirty="0"/>
          </a:p>
          <a:p>
            <a:pPr algn="r"/>
            <a:endParaRPr lang="en-US" sz="500" b="1" dirty="0"/>
          </a:p>
          <a:p>
            <a:pPr algn="r"/>
            <a:r>
              <a:rPr lang="en-US" sz="1100" b="1" dirty="0"/>
              <a:t>GAPD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370FBF-00CC-FC30-0A8A-B41CD31959B7}"/>
              </a:ext>
            </a:extLst>
          </p:cNvPr>
          <p:cNvSpPr txBox="1"/>
          <p:nvPr/>
        </p:nvSpPr>
        <p:spPr>
          <a:xfrm>
            <a:off x="3923364" y="83184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6680751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053AEE3-02BB-7117-0CF6-D63C4B32AE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8506" y="2895752"/>
            <a:ext cx="1676400" cy="23850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BB4B22D-88F7-C2A5-411C-D92E3BBBB9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3988" y="2895752"/>
            <a:ext cx="1676400" cy="23850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657AAD1-F0C5-6F5E-52FA-2958A90C0036}"/>
              </a:ext>
            </a:extLst>
          </p:cNvPr>
          <p:cNvSpPr txBox="1"/>
          <p:nvPr/>
        </p:nvSpPr>
        <p:spPr>
          <a:xfrm rot="16200000">
            <a:off x="4426033" y="1335245"/>
            <a:ext cx="1401346" cy="18435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100" b="1" dirty="0"/>
              <a:t>Contro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YIV-818-A 83 u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YIV-818-A 250 u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 25 n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 75 n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II 8.3 n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II 25 ng/m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184C604-4CA3-F159-BC21-B81B79D89D64}"/>
              </a:ext>
            </a:extLst>
          </p:cNvPr>
          <p:cNvSpPr txBox="1"/>
          <p:nvPr/>
        </p:nvSpPr>
        <p:spPr>
          <a:xfrm rot="16200000">
            <a:off x="6342822" y="1309321"/>
            <a:ext cx="1436612" cy="18435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100" b="1" dirty="0"/>
              <a:t>Contro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YIV-818-A 83 u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Y1V-818-A 250 u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 25 n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 75 n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II 8.3 ng/ml</a:t>
            </a:r>
          </a:p>
          <a:p>
            <a:pPr>
              <a:lnSpc>
                <a:spcPct val="150000"/>
              </a:lnSpc>
            </a:pPr>
            <a:r>
              <a:rPr lang="en-US" sz="1100" b="1" dirty="0"/>
              <a:t>RA-VII 25 ng/m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C8885D-B25E-B9D1-2064-3497D6D1A67C}"/>
              </a:ext>
            </a:extLst>
          </p:cNvPr>
          <p:cNvSpPr txBox="1"/>
          <p:nvPr/>
        </p:nvSpPr>
        <p:spPr>
          <a:xfrm>
            <a:off x="4817733" y="1267923"/>
            <a:ext cx="789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2RV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0B07A6E-9C4C-3C21-502B-841BD8598449}"/>
              </a:ext>
            </a:extLst>
          </p:cNvPr>
          <p:cNvSpPr txBox="1"/>
          <p:nvPr/>
        </p:nvSpPr>
        <p:spPr>
          <a:xfrm>
            <a:off x="6796542" y="1277599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DHT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E36B35C-D399-7411-C14D-3423C4D46849}"/>
              </a:ext>
            </a:extLst>
          </p:cNvPr>
          <p:cNvCxnSpPr>
            <a:cxnSpLocks/>
          </p:cNvCxnSpPr>
          <p:nvPr/>
        </p:nvCxnSpPr>
        <p:spPr>
          <a:xfrm>
            <a:off x="6171774" y="1604030"/>
            <a:ext cx="182562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36FD814C-C9D5-3C4A-7024-478809928BF7}"/>
              </a:ext>
            </a:extLst>
          </p:cNvPr>
          <p:cNvSpPr txBox="1"/>
          <p:nvPr/>
        </p:nvSpPr>
        <p:spPr>
          <a:xfrm>
            <a:off x="156764" y="4239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A3EBB3-E9D7-A99A-AD93-42A56FAE5467}"/>
              </a:ext>
            </a:extLst>
          </p:cNvPr>
          <p:cNvSpPr txBox="1"/>
          <p:nvPr/>
        </p:nvSpPr>
        <p:spPr>
          <a:xfrm>
            <a:off x="2673198" y="5472566"/>
            <a:ext cx="80430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4. </a:t>
            </a:r>
            <a:r>
              <a:rPr lang="en-US" sz="1200" dirty="0"/>
              <a:t>Verification of Equal Protein Loading for Western Blot Analysis at Figure 3C: Coomassie Blue staining demonstrates equivalent protein loading across the various treatment conditions. </a:t>
            </a:r>
          </a:p>
        </p:txBody>
      </p:sp>
    </p:spTree>
    <p:extLst>
      <p:ext uri="{BB962C8B-B14F-4D97-AF65-F5344CB8AC3E}">
        <p14:creationId xmlns:p14="http://schemas.microsoft.com/office/powerpoint/2010/main" val="203819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3</TotalTime>
  <Words>514</Words>
  <Application>Microsoft Office PowerPoint</Application>
  <PresentationFormat>Widescreen</PresentationFormat>
  <Paragraphs>107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g LAM</dc:creator>
  <cp:lastModifiedBy>Wing LAM</cp:lastModifiedBy>
  <cp:revision>152</cp:revision>
  <cp:lastPrinted>2023-05-26T18:39:06Z</cp:lastPrinted>
  <dcterms:created xsi:type="dcterms:W3CDTF">2022-08-11T15:25:17Z</dcterms:created>
  <dcterms:modified xsi:type="dcterms:W3CDTF">2023-08-02T15:16:01Z</dcterms:modified>
</cp:coreProperties>
</file>